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33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842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047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73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9802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83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281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8175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967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6723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801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3139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02EC8F-3AB8-42BE-AEDE-E74A821EAD6B}" type="datetimeFigureOut">
              <a:rPr lang="en-US" smtClean="0"/>
              <a:t>1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7084B8-13D8-4A6F-AC6B-BB454BEBD0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0832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/>
          </p:nvPr>
        </p:nvGraphicFramePr>
        <p:xfrm>
          <a:off x="563138" y="831720"/>
          <a:ext cx="5018000" cy="510133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54500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254500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25450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5450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</a:tblGrid>
              <a:tr h="777929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</a:rPr>
                        <a:t>Treatment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</a:rPr>
                        <a:t>Control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</a:rPr>
                        <a:t> Concentrations (µg/L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</a:rPr>
                        <a:t>)</a:t>
                      </a:r>
                      <a:r>
                        <a:rPr lang="en-US" sz="1100" b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</a:rPr>
                        <a:t>±Standard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</a:rPr>
                        <a:t> Error of the Mean (SEM)</a:t>
                      </a:r>
                      <a:endParaRPr lang="en-US" sz="1100" b="1" dirty="0">
                        <a:solidFill>
                          <a:schemeClr val="tx1"/>
                        </a:solidFill>
                      </a:endParaRP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1" dirty="0">
                          <a:solidFill>
                            <a:schemeClr val="tx1"/>
                          </a:solidFill>
                        </a:rPr>
                        <a:t>12.5% HEWAF Concentrations 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</a:rPr>
                        <a:t>(µg/L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</a:rPr>
                        <a:t>)</a:t>
                      </a:r>
                      <a:r>
                        <a:rPr lang="en-US" sz="1100" b="0" dirty="0" smtClean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</a:rPr>
                        <a:t>±SEM</a:t>
                      </a:r>
                      <a:endParaRPr lang="en-US" sz="1100" b="1" dirty="0">
                        <a:solidFill>
                          <a:schemeClr val="tx1"/>
                        </a:solidFill>
                      </a:endParaRP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solidFill>
                            <a:schemeClr val="tx1"/>
                          </a:solidFill>
                        </a:rPr>
                        <a:t>100%</a:t>
                      </a:r>
                      <a:r>
                        <a:rPr lang="en-US" sz="1100" b="1" baseline="0" dirty="0">
                          <a:solidFill>
                            <a:schemeClr val="tx1"/>
                          </a:solidFill>
                        </a:rPr>
                        <a:t> HEWAF Concentrations (µg/L</a:t>
                      </a:r>
                      <a:r>
                        <a:rPr lang="en-US" sz="1100" b="1" baseline="0" dirty="0" smtClean="0">
                          <a:solidFill>
                            <a:schemeClr val="tx1"/>
                          </a:solidFill>
                        </a:rPr>
                        <a:t>)</a:t>
                      </a:r>
                      <a:r>
                        <a:rPr lang="en-US" sz="1100" b="1" dirty="0" smtClean="0">
                          <a:solidFill>
                            <a:schemeClr val="tx1"/>
                          </a:solidFill>
                        </a:rPr>
                        <a:t> ±SEM</a:t>
                      </a:r>
                      <a:endParaRPr lang="en-US" sz="1100" b="1" dirty="0">
                        <a:solidFill>
                          <a:schemeClr val="tx1"/>
                        </a:solidFill>
                      </a:endParaRP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Embryonic, norm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13.38±0.02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128.61±6.94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368.55±11.15 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Embryonic, hyp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20.59±0.08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168.05±27.80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501.12±30.63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Post-hatch, norm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8.82±0.05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69.79±2.18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242.15±9.07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Post-hatch, hyp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25.71±0.49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115.39±4.40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511.75±30.88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Post-larval, norm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7.10±0.06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82.64±4.85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274.00±4.93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701950">
                <a:tc>
                  <a:txBody>
                    <a:bodyPr/>
                    <a:lstStyle/>
                    <a:p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Post-larval, hypoxic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42.96±0.16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97.48±4.31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b="0" dirty="0">
                          <a:solidFill>
                            <a:schemeClr val="tx1"/>
                          </a:solidFill>
                        </a:rPr>
                        <a:t>293.20±111.66</a:t>
                      </a:r>
                    </a:p>
                  </a:txBody>
                  <a:tcPr marL="51435" marR="51435" marT="25717" marB="25717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0" y="6367997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1</a:t>
            </a:r>
            <a:r>
              <a:rPr lang="en-US" dirty="0"/>
              <a:t>. 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="" xmlns:a16="http://schemas.microsoft.com/office/drawing/2014/main" id="{D04C3931-8B44-473B-8C08-D8F8E0AA94A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796792" y="831720"/>
          <a:ext cx="6395208" cy="4404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480682">
                  <a:extLst>
                    <a:ext uri="{9D8B030D-6E8A-4147-A177-3AD203B41FA5}">
                      <a16:colId xmlns="" xmlns:a16="http://schemas.microsoft.com/office/drawing/2014/main" val="1671576552"/>
                    </a:ext>
                  </a:extLst>
                </a:gridCol>
                <a:gridCol w="1782790">
                  <a:extLst>
                    <a:ext uri="{9D8B030D-6E8A-4147-A177-3AD203B41FA5}">
                      <a16:colId xmlns="" xmlns:a16="http://schemas.microsoft.com/office/drawing/2014/main" val="1795680670"/>
                    </a:ext>
                  </a:extLst>
                </a:gridCol>
                <a:gridCol w="2131736">
                  <a:extLst>
                    <a:ext uri="{9D8B030D-6E8A-4147-A177-3AD203B41FA5}">
                      <a16:colId xmlns="" xmlns:a16="http://schemas.microsoft.com/office/drawing/2014/main" val="1709767681"/>
                    </a:ext>
                  </a:extLst>
                </a:gridCol>
              </a:tblGrid>
              <a:tr h="245394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Parent PAH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Alkyl PAH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Alkyl PAH homolog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761781932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2-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670266521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Acenaphthy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2,6-d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D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788384326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Acenaphth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1,3-d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Tr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487451049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Fluo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1,5-d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Methyl fluo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736005488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Phenanth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2,3,5-trimethyl naphtha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Methyl phenanth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522323326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Anthrac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1-methyl fluo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1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89939849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Fluoranth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3-methyl phenanth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62168750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Py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9-methyl phenanth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246975324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Benzo(a)anthrac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8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70479257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Chrys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889468437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Benzo(b)fluoranth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33902628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Benzo(k)fluoranth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795232082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Benzo(a)py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797224907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 err="1">
                          <a:solidFill>
                            <a:schemeClr val="tx1"/>
                          </a:solidFill>
                        </a:rPr>
                        <a:t>Indeno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(1,2,3-cd)pyr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60091920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Dibenzo(ash)anthrac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147866435"/>
                  </a:ext>
                </a:extLst>
              </a:tr>
              <a:tr h="245394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Benzo(</a:t>
                      </a:r>
                      <a:r>
                        <a:rPr lang="en-US" sz="1100" dirty="0" err="1">
                          <a:solidFill>
                            <a:schemeClr val="tx1"/>
                          </a:solidFill>
                        </a:rPr>
                        <a:t>g,h,i</a:t>
                      </a:r>
                      <a:r>
                        <a:rPr lang="en-US" sz="1100" dirty="0">
                          <a:solidFill>
                            <a:schemeClr val="tx1"/>
                          </a:solidFill>
                        </a:rPr>
                        <a:t>)perylen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88318647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C9FACBEC-9782-40FE-A8FD-FA5A27C81D1F}"/>
              </a:ext>
            </a:extLst>
          </p:cNvPr>
          <p:cNvSpPr txBox="1"/>
          <p:nvPr/>
        </p:nvSpPr>
        <p:spPr>
          <a:xfrm>
            <a:off x="563138" y="155430"/>
            <a:ext cx="5025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03D66480-4D73-4219-ACB4-2A48BD2129E3}"/>
              </a:ext>
            </a:extLst>
          </p:cNvPr>
          <p:cNvSpPr txBox="1"/>
          <p:nvPr/>
        </p:nvSpPr>
        <p:spPr>
          <a:xfrm>
            <a:off x="5796792" y="155430"/>
            <a:ext cx="50250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2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4510069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map&#10;&#10;Description automatically generated">
            <a:extLst>
              <a:ext uri="{FF2B5EF4-FFF2-40B4-BE49-F238E27FC236}">
                <a16:creationId xmlns:a16="http://schemas.microsoft.com/office/drawing/2014/main" xmlns="" id="{CCEF2E82-DAE3-476F-A845-F2A0427C7F6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142"/>
          <a:stretch/>
        </p:blipFill>
        <p:spPr>
          <a:xfrm>
            <a:off x="2424867" y="331470"/>
            <a:ext cx="8230960" cy="587279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0" y="6318505"/>
            <a:ext cx="12192000" cy="3694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1" dirty="0" smtClean="0"/>
              <a:t>Figure S1. </a:t>
            </a:r>
            <a:endParaRPr lang="en-US" sz="1801" dirty="0"/>
          </a:p>
        </p:txBody>
      </p:sp>
    </p:spTree>
    <p:extLst>
      <p:ext uri="{BB962C8B-B14F-4D97-AF65-F5344CB8AC3E}">
        <p14:creationId xmlns:p14="http://schemas.microsoft.com/office/powerpoint/2010/main" val="4265142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Widescreen</PresentationFormat>
  <Paragraphs>6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University of Southern Mississippi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Rodgers</dc:creator>
  <cp:lastModifiedBy>Maria Rodgers</cp:lastModifiedBy>
  <cp:revision>1</cp:revision>
  <dcterms:created xsi:type="dcterms:W3CDTF">2020-01-16T15:25:43Z</dcterms:created>
  <dcterms:modified xsi:type="dcterms:W3CDTF">2020-01-16T15:26:08Z</dcterms:modified>
</cp:coreProperties>
</file>